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6" r:id="rId2"/>
  </p:sldIdLst>
  <p:sldSz cx="12192000" cy="6858000"/>
  <p:notesSz cx="6858000" cy="9144000"/>
  <p:defaultTextStyle>
    <a:defPPr>
      <a:defRPr lang="en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6" autoAdjust="0"/>
    <p:restoredTop sz="94660"/>
  </p:normalViewPr>
  <p:slideViewPr>
    <p:cSldViewPr snapToGrid="0" showGuides="1">
      <p:cViewPr varScale="1">
        <p:scale>
          <a:sx n="113" d="100"/>
          <a:sy n="113" d="100"/>
        </p:scale>
        <p:origin x="840" y="91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192B63-A979-4CAD-F51F-D835D6E4550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AF9FF1B-6556-3108-7E41-6B7FB14FE55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64458C0-C5A2-A9E2-1B8C-AC17E557F2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E4CD3C-87BC-4657-A3D3-458F5727B37A}" type="datetimeFigureOut">
              <a:rPr lang="en-DE" smtClean="0"/>
              <a:t>13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A7EF473-95EA-4FED-E4CC-32C0FCA565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F5744CD-9CFC-E337-F357-B4AE6B1961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B9F544-2CC2-44F4-A52E-C1E09D09C95B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9406786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D419868-FF99-7904-FE43-5D385B44DE7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8079F2F-5AA8-3C6A-5A3D-54721230AD3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B54729E-8EF7-430E-9E55-354E0BC47B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E4CD3C-87BC-4657-A3D3-458F5727B37A}" type="datetimeFigureOut">
              <a:rPr lang="en-DE" smtClean="0"/>
              <a:t>13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E45216C-B6EE-3F84-F84C-FAB8273DA4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11F37C8-9289-CF59-EAC1-831FCEFE89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B9F544-2CC2-44F4-A52E-C1E09D09C95B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5328176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D94E36D-DF13-A8D6-C559-661264277B1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BB8A1F0-9EB5-FEA7-0B95-31E5A2DD181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2BEAFA6-6702-408C-B4A4-C3ABE08006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E4CD3C-87BC-4657-A3D3-458F5727B37A}" type="datetimeFigureOut">
              <a:rPr lang="en-DE" smtClean="0"/>
              <a:t>13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17BE483-7FCE-F552-0FBC-30B10A084E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A36F566-3AA0-9DA1-DD91-532CF0FB42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B9F544-2CC2-44F4-A52E-C1E09D09C95B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875326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2FEE7E-A643-7AB1-40D3-E55C380C284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0E28AF7-D629-E088-C26C-15D26B1AA53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7DC4B5A-F90B-6376-6D23-D3F7711ACF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E4CD3C-87BC-4657-A3D3-458F5727B37A}" type="datetimeFigureOut">
              <a:rPr lang="en-DE" smtClean="0"/>
              <a:t>13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3C44848-CF4A-0A34-CA7B-91DB13E59F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95A7894-28D6-DA1C-7110-9D981785CE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B9F544-2CC2-44F4-A52E-C1E09D09C95B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5468703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A13D057-E62E-6ECF-6373-4CB7C5EA090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277575E-E13F-FC56-FFF6-E28C7D376CD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52FB02C-C8C0-573A-A867-85FA3822B7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E4CD3C-87BC-4657-A3D3-458F5727B37A}" type="datetimeFigureOut">
              <a:rPr lang="en-DE" smtClean="0"/>
              <a:t>13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703C177-EF3F-4908-0F30-BB7C4F6BDE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13C9802-2EB6-ED86-1C68-755F02D648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B9F544-2CC2-44F4-A52E-C1E09D09C95B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6517095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53532C-1C3B-21FB-AE25-8909F438038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25EA227-83DE-42C9-233F-0B0B14CD991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EB01F5F-4CF1-CA23-252F-864C157538F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DFC842B-9F3D-06E0-0394-26DDEC76AB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E4CD3C-87BC-4657-A3D3-458F5727B37A}" type="datetimeFigureOut">
              <a:rPr lang="en-DE" smtClean="0"/>
              <a:t>13/08/2024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C84E42F-6FCA-45CD-7E4A-78D166D158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F8D0F63-15E7-8490-C54B-4B51A0C8AB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B9F544-2CC2-44F4-A52E-C1E09D09C95B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9824998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90EB43-B69B-BBFF-A564-44ECE3BDED6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A3BD9D9-5F04-438F-AAD3-D2D81CF8C25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E6A697E-5965-BCB8-80C5-8256D785A0C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4E7AF72-A587-BC48-7A46-0089B9865B1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2F94DDD-B5D8-2719-DC60-F0A6BAD822D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3A08A01-18B8-ED76-A6C9-2CFF92A86B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E4CD3C-87BC-4657-A3D3-458F5727B37A}" type="datetimeFigureOut">
              <a:rPr lang="en-DE" smtClean="0"/>
              <a:t>13/08/2024</a:t>
            </a:fld>
            <a:endParaRPr lang="en-DE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34FC92D-FA79-7B03-79DD-6E4DC0382A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C880C5E-913E-DA93-087E-9196679E76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B9F544-2CC2-44F4-A52E-C1E09D09C95B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40081296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DF90965-C9F7-6238-A58A-6575FCCE915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50980C1-259B-0E7B-2BA9-D24D1529B1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E4CD3C-87BC-4657-A3D3-458F5727B37A}" type="datetimeFigureOut">
              <a:rPr lang="en-DE" smtClean="0"/>
              <a:t>13/08/2024</a:t>
            </a:fld>
            <a:endParaRPr lang="en-DE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E1DABFF-E278-E0A1-B16F-25D2F70060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5C4851B-113D-AD03-DF1E-0C15279CAA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B9F544-2CC2-44F4-A52E-C1E09D09C95B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8021544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ABFDF72-EAB3-3CC7-A336-8DC743BE36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E4CD3C-87BC-4657-A3D3-458F5727B37A}" type="datetimeFigureOut">
              <a:rPr lang="en-DE" smtClean="0"/>
              <a:t>13/08/2024</a:t>
            </a:fld>
            <a:endParaRPr lang="en-D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444496C-E452-C85B-DA04-67F556176C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4D88940-1C82-4716-2262-334D176A16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B9F544-2CC2-44F4-A52E-C1E09D09C95B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8379882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00E071-CAE9-7AA6-6EDB-2CCB3B33E2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12D03E0-3D25-FE33-A0CA-16A3E70ACC6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6F4642C-6508-44C7-2BCD-65581A89E8F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2CD07E1-2D0D-B23E-413D-85B124FE32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E4CD3C-87BC-4657-A3D3-458F5727B37A}" type="datetimeFigureOut">
              <a:rPr lang="en-DE" smtClean="0"/>
              <a:t>13/08/2024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87E989D-B8FB-70A6-845E-D58031D9BD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250DA1D-7B58-8918-C47E-22C52AC8C1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B9F544-2CC2-44F4-A52E-C1E09D09C95B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7526267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2B6334-329C-99E9-F961-5902A636A3E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3574453-16A7-4A42-9863-B19F48B5327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94E1E22-1219-59F5-13FC-65B0730221C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9C30A03-3E58-B2F2-7A6F-BA3D32A0F7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E4CD3C-87BC-4657-A3D3-458F5727B37A}" type="datetimeFigureOut">
              <a:rPr lang="en-DE" smtClean="0"/>
              <a:t>13/08/2024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B4A9EA3-72D5-B88A-4134-D417E93C40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1100866-B542-8A13-C969-D87D4F42CE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B9F544-2CC2-44F4-A52E-C1E09D09C95B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9977068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38AEB33-A445-F45D-BD8C-EFB65F1986A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FA85D29-A683-827A-42D6-0342D548010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94E607A-F00F-95B0-92EB-D60CB67C380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7E4CD3C-87BC-4657-A3D3-458F5727B37A}" type="datetimeFigureOut">
              <a:rPr lang="en-DE" smtClean="0"/>
              <a:t>13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347BB5E-A97E-8825-DBCC-19B1224F5AD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B8C7B31-6D6F-7931-D706-CE8390B330F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DB9F544-2CC2-44F4-A52E-C1E09D09C95B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3958967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2AE0A962-C6BD-4E28-BCD1-508904C07DE2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381" t="46699" r="57000" b="12008"/>
          <a:stretch/>
        </p:blipFill>
        <p:spPr bwMode="auto">
          <a:xfrm>
            <a:off x="2122801" y="2876230"/>
            <a:ext cx="3350956" cy="2610676"/>
          </a:xfrm>
          <a:prstGeom prst="rect">
            <a:avLst/>
          </a:prstGeom>
          <a:ln>
            <a:noFill/>
          </a:ln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103F58F2-577B-4E62-AC71-2DC817A4C951}"/>
              </a:ext>
            </a:extLst>
          </p:cNvPr>
          <p:cNvSpPr/>
          <p:nvPr/>
        </p:nvSpPr>
        <p:spPr>
          <a:xfrm>
            <a:off x="2794141" y="4012934"/>
            <a:ext cx="1998420" cy="276999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0EEE545A-E449-4477-A223-7AAD32205024}"/>
              </a:ext>
            </a:extLst>
          </p:cNvPr>
          <p:cNvSpPr txBox="1"/>
          <p:nvPr/>
        </p:nvSpPr>
        <p:spPr>
          <a:xfrm>
            <a:off x="5105384" y="4027679"/>
            <a:ext cx="8242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en-DE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5AB51C28-09A8-A3D3-96AE-526E8A8F4368}"/>
              </a:ext>
            </a:extLst>
          </p:cNvPr>
          <p:cNvSpPr txBox="1"/>
          <p:nvPr/>
        </p:nvSpPr>
        <p:spPr>
          <a:xfrm>
            <a:off x="2817374" y="2422172"/>
            <a:ext cx="3898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V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3D301D78-3740-DB1F-F4F6-D9F4E3B85429}"/>
              </a:ext>
            </a:extLst>
          </p:cNvPr>
          <p:cNvSpPr txBox="1"/>
          <p:nvPr/>
        </p:nvSpPr>
        <p:spPr>
          <a:xfrm>
            <a:off x="1597181" y="2693394"/>
            <a:ext cx="11705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ox +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Cumate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273F153-CE0B-7008-96D4-FE69CC9C1667}"/>
              </a:ext>
            </a:extLst>
          </p:cNvPr>
          <p:cNvSpPr txBox="1"/>
          <p:nvPr/>
        </p:nvSpPr>
        <p:spPr>
          <a:xfrm>
            <a:off x="2804123" y="2662616"/>
            <a:ext cx="19371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Symbol" panose="05050102010706020507" pitchFamily="18" charset="2"/>
                <a:cs typeface="Arial" panose="020B0604020202020204" pitchFamily="34" charset="0"/>
              </a:rPr>
              <a:t>+   +   +   +    +   +   +   +</a:t>
            </a:r>
            <a:endParaRPr lang="en-DE" sz="14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3F977BD-51DB-3089-2276-3463590D79D9}"/>
              </a:ext>
            </a:extLst>
          </p:cNvPr>
          <p:cNvSpPr txBox="1"/>
          <p:nvPr/>
        </p:nvSpPr>
        <p:spPr>
          <a:xfrm rot="16200000">
            <a:off x="3541122" y="1932396"/>
            <a:ext cx="98777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L-NG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S-Sc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DC03347C-7CE3-1690-81C3-6E0E40DA9B98}"/>
              </a:ext>
            </a:extLst>
          </p:cNvPr>
          <p:cNvSpPr txBox="1"/>
          <p:nvPr/>
        </p:nvSpPr>
        <p:spPr>
          <a:xfrm>
            <a:off x="1885067" y="2970393"/>
            <a:ext cx="9092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mricasan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8386C912-D766-B74C-722B-0873AE5E3356}"/>
              </a:ext>
            </a:extLst>
          </p:cNvPr>
          <p:cNvSpPr txBox="1"/>
          <p:nvPr/>
        </p:nvSpPr>
        <p:spPr>
          <a:xfrm rot="16200000">
            <a:off x="3851406" y="1809343"/>
            <a:ext cx="131799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L-NG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mZ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S-Sc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1AB8A8AA-B7FA-4F12-5FD2-F5CD8A9589E1}"/>
              </a:ext>
            </a:extLst>
          </p:cNvPr>
          <p:cNvCxnSpPr>
            <a:cxnSpLocks/>
          </p:cNvCxnSpPr>
          <p:nvPr/>
        </p:nvCxnSpPr>
        <p:spPr>
          <a:xfrm>
            <a:off x="2807542" y="2657114"/>
            <a:ext cx="412934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5B81996F-6081-0EB6-9339-45D507142931}"/>
              </a:ext>
            </a:extLst>
          </p:cNvPr>
          <p:cNvCxnSpPr>
            <a:cxnSpLocks/>
          </p:cNvCxnSpPr>
          <p:nvPr/>
        </p:nvCxnSpPr>
        <p:spPr>
          <a:xfrm>
            <a:off x="3324377" y="2657114"/>
            <a:ext cx="412934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8C4C6A66-CD00-2B72-2FCF-B92C2B641088}"/>
              </a:ext>
            </a:extLst>
          </p:cNvPr>
          <p:cNvCxnSpPr>
            <a:cxnSpLocks/>
          </p:cNvCxnSpPr>
          <p:nvPr/>
        </p:nvCxnSpPr>
        <p:spPr>
          <a:xfrm>
            <a:off x="3824137" y="2657114"/>
            <a:ext cx="412934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B85E3025-503D-A613-B260-61576CDF62C0}"/>
              </a:ext>
            </a:extLst>
          </p:cNvPr>
          <p:cNvCxnSpPr>
            <a:cxnSpLocks/>
          </p:cNvCxnSpPr>
          <p:nvPr/>
        </p:nvCxnSpPr>
        <p:spPr>
          <a:xfrm>
            <a:off x="4303935" y="2657363"/>
            <a:ext cx="412934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id="{B9B46381-A139-4FF9-8641-FCCA4602904A}"/>
              </a:ext>
            </a:extLst>
          </p:cNvPr>
          <p:cNvSpPr txBox="1"/>
          <p:nvPr/>
        </p:nvSpPr>
        <p:spPr>
          <a:xfrm rot="16200000">
            <a:off x="3026138" y="2066786"/>
            <a:ext cx="9877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L-NG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BBD4DCDE-03BB-C299-3DE6-A1406A6A17BD}"/>
              </a:ext>
            </a:extLst>
          </p:cNvPr>
          <p:cNvSpPr txBox="1"/>
          <p:nvPr/>
        </p:nvSpPr>
        <p:spPr>
          <a:xfrm>
            <a:off x="2799131" y="2902597"/>
            <a:ext cx="19470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Symbol" panose="05050102010706020507" pitchFamily="18" charset="2"/>
                <a:cs typeface="Arial" panose="020B0604020202020204" pitchFamily="34" charset="0"/>
              </a:rPr>
              <a:t>-   +   -   +    -   +   -   +</a:t>
            </a:r>
            <a:endParaRPr lang="en-DE" sz="14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pic>
        <p:nvPicPr>
          <p:cNvPr id="17" name="Picture 16">
            <a:extLst>
              <a:ext uri="{FF2B5EF4-FFF2-40B4-BE49-F238E27FC236}">
                <a16:creationId xmlns:a16="http://schemas.microsoft.com/office/drawing/2014/main" id="{6FDA70D1-B314-9908-0D7C-6197D4475BDB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60" t="6119" r="59943" b="54676"/>
          <a:stretch/>
        </p:blipFill>
        <p:spPr bwMode="auto">
          <a:xfrm>
            <a:off x="7481872" y="2822089"/>
            <a:ext cx="2902226" cy="2544417"/>
          </a:xfrm>
          <a:prstGeom prst="rect">
            <a:avLst/>
          </a:prstGeom>
          <a:ln>
            <a:noFill/>
          </a:ln>
        </p:spPr>
      </p:pic>
      <p:sp>
        <p:nvSpPr>
          <p:cNvPr id="18" name="Rectangle 17">
            <a:extLst>
              <a:ext uri="{FF2B5EF4-FFF2-40B4-BE49-F238E27FC236}">
                <a16:creationId xmlns:a16="http://schemas.microsoft.com/office/drawing/2014/main" id="{D5163D18-97A6-5A3F-9C91-2EB1C05F1F9E}"/>
              </a:ext>
            </a:extLst>
          </p:cNvPr>
          <p:cNvSpPr/>
          <p:nvPr/>
        </p:nvSpPr>
        <p:spPr>
          <a:xfrm>
            <a:off x="7759402" y="4034637"/>
            <a:ext cx="2040413" cy="29333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F153CCFF-D978-7276-93E8-D8DDB7FECA8B}"/>
              </a:ext>
            </a:extLst>
          </p:cNvPr>
          <p:cNvSpPr txBox="1"/>
          <p:nvPr/>
        </p:nvSpPr>
        <p:spPr>
          <a:xfrm>
            <a:off x="10384098" y="4034637"/>
            <a:ext cx="8242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en-DE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7CD2B5E0-FB4A-E67B-08B4-201536EED4E6}"/>
              </a:ext>
            </a:extLst>
          </p:cNvPr>
          <p:cNvSpPr txBox="1"/>
          <p:nvPr/>
        </p:nvSpPr>
        <p:spPr>
          <a:xfrm>
            <a:off x="7870965" y="2490236"/>
            <a:ext cx="3898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V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13B63542-F3DF-2634-704B-8B5E75BE2437}"/>
              </a:ext>
            </a:extLst>
          </p:cNvPr>
          <p:cNvSpPr txBox="1"/>
          <p:nvPr/>
        </p:nvSpPr>
        <p:spPr>
          <a:xfrm>
            <a:off x="6672970" y="2767235"/>
            <a:ext cx="11705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ox +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Cumate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8D377560-64E5-4ACB-CE5A-934E4119FFB5}"/>
              </a:ext>
            </a:extLst>
          </p:cNvPr>
          <p:cNvSpPr txBox="1"/>
          <p:nvPr/>
        </p:nvSpPr>
        <p:spPr>
          <a:xfrm>
            <a:off x="7857714" y="2730680"/>
            <a:ext cx="19371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Symbol" panose="05050102010706020507" pitchFamily="18" charset="2"/>
                <a:cs typeface="Arial" panose="020B0604020202020204" pitchFamily="34" charset="0"/>
              </a:rPr>
              <a:t>+   +   +   +    +   +   +   +</a:t>
            </a:r>
            <a:endParaRPr lang="en-DE" sz="14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46DC03D1-EC30-0A2C-530F-00901C1D865B}"/>
              </a:ext>
            </a:extLst>
          </p:cNvPr>
          <p:cNvSpPr txBox="1"/>
          <p:nvPr/>
        </p:nvSpPr>
        <p:spPr>
          <a:xfrm rot="16200000">
            <a:off x="8594713" y="2000460"/>
            <a:ext cx="98777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L-NG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S-Sc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4331C848-4D30-5E4A-D999-0D19B3CC097C}"/>
              </a:ext>
            </a:extLst>
          </p:cNvPr>
          <p:cNvSpPr txBox="1"/>
          <p:nvPr/>
        </p:nvSpPr>
        <p:spPr>
          <a:xfrm>
            <a:off x="6938509" y="2996098"/>
            <a:ext cx="9092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mricasan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6A6F7A63-F17D-4812-B742-3C1B977BB425}"/>
              </a:ext>
            </a:extLst>
          </p:cNvPr>
          <p:cNvSpPr txBox="1"/>
          <p:nvPr/>
        </p:nvSpPr>
        <p:spPr>
          <a:xfrm rot="16200000">
            <a:off x="8904997" y="1877407"/>
            <a:ext cx="131799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L-NG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mZ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S-Sc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632E6114-E9F4-0584-2BBC-BE1DA2812DEA}"/>
              </a:ext>
            </a:extLst>
          </p:cNvPr>
          <p:cNvCxnSpPr>
            <a:cxnSpLocks/>
          </p:cNvCxnSpPr>
          <p:nvPr/>
        </p:nvCxnSpPr>
        <p:spPr>
          <a:xfrm>
            <a:off x="7861133" y="2725178"/>
            <a:ext cx="412934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DBD981DF-8FEE-10A1-F444-6BF8F15C6FE4}"/>
              </a:ext>
            </a:extLst>
          </p:cNvPr>
          <p:cNvCxnSpPr>
            <a:cxnSpLocks/>
          </p:cNvCxnSpPr>
          <p:nvPr/>
        </p:nvCxnSpPr>
        <p:spPr>
          <a:xfrm>
            <a:off x="8377968" y="2725178"/>
            <a:ext cx="412934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5AA2F1D6-FDA9-3DCC-46AC-E401CEFD0B8A}"/>
              </a:ext>
            </a:extLst>
          </p:cNvPr>
          <p:cNvCxnSpPr>
            <a:cxnSpLocks/>
          </p:cNvCxnSpPr>
          <p:nvPr/>
        </p:nvCxnSpPr>
        <p:spPr>
          <a:xfrm>
            <a:off x="8877728" y="2725178"/>
            <a:ext cx="412934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A7671823-9BB8-0FB1-7041-83262127C62A}"/>
              </a:ext>
            </a:extLst>
          </p:cNvPr>
          <p:cNvCxnSpPr>
            <a:cxnSpLocks/>
          </p:cNvCxnSpPr>
          <p:nvPr/>
        </p:nvCxnSpPr>
        <p:spPr>
          <a:xfrm>
            <a:off x="9357526" y="2725427"/>
            <a:ext cx="412934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" name="TextBox 29">
            <a:extLst>
              <a:ext uri="{FF2B5EF4-FFF2-40B4-BE49-F238E27FC236}">
                <a16:creationId xmlns:a16="http://schemas.microsoft.com/office/drawing/2014/main" id="{14CA9699-8478-BDCB-E6A3-851440A3CA8F}"/>
              </a:ext>
            </a:extLst>
          </p:cNvPr>
          <p:cNvSpPr txBox="1"/>
          <p:nvPr/>
        </p:nvSpPr>
        <p:spPr>
          <a:xfrm rot="16200000">
            <a:off x="8079729" y="2134850"/>
            <a:ext cx="9877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L-NG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9F5996B5-DC04-0511-E2F8-16029D5B9936}"/>
              </a:ext>
            </a:extLst>
          </p:cNvPr>
          <p:cNvSpPr txBox="1"/>
          <p:nvPr/>
        </p:nvSpPr>
        <p:spPr>
          <a:xfrm>
            <a:off x="7852722" y="2970661"/>
            <a:ext cx="19470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Symbol" panose="05050102010706020507" pitchFamily="18" charset="2"/>
                <a:cs typeface="Arial" panose="020B0604020202020204" pitchFamily="34" charset="0"/>
              </a:rPr>
              <a:t>-   +   -   +    -   +   -   +</a:t>
            </a:r>
            <a:endParaRPr lang="en-DE" sz="14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2699224B-3BD3-99C6-F032-370030E0F5A5}"/>
              </a:ext>
            </a:extLst>
          </p:cNvPr>
          <p:cNvSpPr txBox="1"/>
          <p:nvPr/>
        </p:nvSpPr>
        <p:spPr>
          <a:xfrm>
            <a:off x="1661473" y="1110187"/>
            <a:ext cx="64312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Blot 1</a:t>
            </a:r>
            <a:endParaRPr lang="en-DE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6539C09B-B16A-5040-9E20-78E394796B09}"/>
              </a:ext>
            </a:extLst>
          </p:cNvPr>
          <p:cNvSpPr txBox="1"/>
          <p:nvPr/>
        </p:nvSpPr>
        <p:spPr>
          <a:xfrm>
            <a:off x="6799427" y="1110188"/>
            <a:ext cx="64312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Blot 2</a:t>
            </a:r>
            <a:endParaRPr lang="en-DE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2" name="Straight Connector 51">
            <a:extLst>
              <a:ext uri="{FF2B5EF4-FFF2-40B4-BE49-F238E27FC236}">
                <a16:creationId xmlns:a16="http://schemas.microsoft.com/office/drawing/2014/main" id="{096DBD56-E31F-4889-8266-90691A40BF39}"/>
              </a:ext>
            </a:extLst>
          </p:cNvPr>
          <p:cNvCxnSpPr>
            <a:cxnSpLocks/>
          </p:cNvCxnSpPr>
          <p:nvPr/>
        </p:nvCxnSpPr>
        <p:spPr>
          <a:xfrm>
            <a:off x="2498172" y="4138535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3" name="TextBox 36">
            <a:extLst>
              <a:ext uri="{FF2B5EF4-FFF2-40B4-BE49-F238E27FC236}">
                <a16:creationId xmlns:a16="http://schemas.microsoft.com/office/drawing/2014/main" id="{58587A93-CD76-4D57-9C80-CEB715E9BB90}"/>
              </a:ext>
            </a:extLst>
          </p:cNvPr>
          <p:cNvSpPr txBox="1"/>
          <p:nvPr/>
        </p:nvSpPr>
        <p:spPr>
          <a:xfrm>
            <a:off x="2169786" y="3996465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4" name="Straight Connector 53">
            <a:extLst>
              <a:ext uri="{FF2B5EF4-FFF2-40B4-BE49-F238E27FC236}">
                <a16:creationId xmlns:a16="http://schemas.microsoft.com/office/drawing/2014/main" id="{160F0D41-87FD-4E3E-906B-0DC88574D6A7}"/>
              </a:ext>
            </a:extLst>
          </p:cNvPr>
          <p:cNvCxnSpPr>
            <a:cxnSpLocks/>
          </p:cNvCxnSpPr>
          <p:nvPr/>
        </p:nvCxnSpPr>
        <p:spPr>
          <a:xfrm>
            <a:off x="2498172" y="4408223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5" name="TextBox 38">
            <a:extLst>
              <a:ext uri="{FF2B5EF4-FFF2-40B4-BE49-F238E27FC236}">
                <a16:creationId xmlns:a16="http://schemas.microsoft.com/office/drawing/2014/main" id="{A78461CE-6122-42BE-B509-C16961009719}"/>
              </a:ext>
            </a:extLst>
          </p:cNvPr>
          <p:cNvSpPr txBox="1"/>
          <p:nvPr/>
        </p:nvSpPr>
        <p:spPr>
          <a:xfrm>
            <a:off x="2169786" y="4266153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6" name="Straight Connector 55">
            <a:extLst>
              <a:ext uri="{FF2B5EF4-FFF2-40B4-BE49-F238E27FC236}">
                <a16:creationId xmlns:a16="http://schemas.microsoft.com/office/drawing/2014/main" id="{0C47323C-84A6-4D59-B5C4-42B9101C4337}"/>
              </a:ext>
            </a:extLst>
          </p:cNvPr>
          <p:cNvCxnSpPr>
            <a:cxnSpLocks/>
          </p:cNvCxnSpPr>
          <p:nvPr/>
        </p:nvCxnSpPr>
        <p:spPr>
          <a:xfrm>
            <a:off x="2504308" y="3780611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7" name="TextBox 40">
            <a:extLst>
              <a:ext uri="{FF2B5EF4-FFF2-40B4-BE49-F238E27FC236}">
                <a16:creationId xmlns:a16="http://schemas.microsoft.com/office/drawing/2014/main" id="{5F972984-8D28-48E2-9F97-F9D6C12641FD}"/>
              </a:ext>
            </a:extLst>
          </p:cNvPr>
          <p:cNvSpPr txBox="1"/>
          <p:nvPr/>
        </p:nvSpPr>
        <p:spPr>
          <a:xfrm>
            <a:off x="2175922" y="3638541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8" name="Straight Connector 57">
            <a:extLst>
              <a:ext uri="{FF2B5EF4-FFF2-40B4-BE49-F238E27FC236}">
                <a16:creationId xmlns:a16="http://schemas.microsoft.com/office/drawing/2014/main" id="{E9AA08A2-079F-45BE-B055-DBB023E43004}"/>
              </a:ext>
            </a:extLst>
          </p:cNvPr>
          <p:cNvCxnSpPr>
            <a:cxnSpLocks/>
          </p:cNvCxnSpPr>
          <p:nvPr/>
        </p:nvCxnSpPr>
        <p:spPr>
          <a:xfrm>
            <a:off x="2498172" y="3575810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9" name="TextBox 42">
            <a:extLst>
              <a:ext uri="{FF2B5EF4-FFF2-40B4-BE49-F238E27FC236}">
                <a16:creationId xmlns:a16="http://schemas.microsoft.com/office/drawing/2014/main" id="{714B8039-BF18-4EE2-A633-0B6C061D346B}"/>
              </a:ext>
            </a:extLst>
          </p:cNvPr>
          <p:cNvSpPr txBox="1"/>
          <p:nvPr/>
        </p:nvSpPr>
        <p:spPr>
          <a:xfrm>
            <a:off x="2169786" y="3426967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0" name="Straight Connector 59">
            <a:extLst>
              <a:ext uri="{FF2B5EF4-FFF2-40B4-BE49-F238E27FC236}">
                <a16:creationId xmlns:a16="http://schemas.microsoft.com/office/drawing/2014/main" id="{10A1FB5A-889C-48CC-B587-AD5C26C1615F}"/>
              </a:ext>
            </a:extLst>
          </p:cNvPr>
          <p:cNvCxnSpPr>
            <a:cxnSpLocks/>
          </p:cNvCxnSpPr>
          <p:nvPr/>
        </p:nvCxnSpPr>
        <p:spPr>
          <a:xfrm>
            <a:off x="2498172" y="3442910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1" name="TextBox 42">
            <a:extLst>
              <a:ext uri="{FF2B5EF4-FFF2-40B4-BE49-F238E27FC236}">
                <a16:creationId xmlns:a16="http://schemas.microsoft.com/office/drawing/2014/main" id="{60DDE3E3-EC12-4E0C-8B03-DB80A7B22F51}"/>
              </a:ext>
            </a:extLst>
          </p:cNvPr>
          <p:cNvSpPr txBox="1"/>
          <p:nvPr/>
        </p:nvSpPr>
        <p:spPr>
          <a:xfrm>
            <a:off x="2084826" y="3294067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2" name="Straight Connector 61">
            <a:extLst>
              <a:ext uri="{FF2B5EF4-FFF2-40B4-BE49-F238E27FC236}">
                <a16:creationId xmlns:a16="http://schemas.microsoft.com/office/drawing/2014/main" id="{C0B30A25-269B-4108-A31A-330BDFC1056B}"/>
              </a:ext>
            </a:extLst>
          </p:cNvPr>
          <p:cNvCxnSpPr>
            <a:cxnSpLocks/>
          </p:cNvCxnSpPr>
          <p:nvPr/>
        </p:nvCxnSpPr>
        <p:spPr>
          <a:xfrm>
            <a:off x="7442787" y="4172400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3" name="TextBox 36">
            <a:extLst>
              <a:ext uri="{FF2B5EF4-FFF2-40B4-BE49-F238E27FC236}">
                <a16:creationId xmlns:a16="http://schemas.microsoft.com/office/drawing/2014/main" id="{382AA6CC-A865-4B4A-84E0-C1CAC50A15EC}"/>
              </a:ext>
            </a:extLst>
          </p:cNvPr>
          <p:cNvSpPr txBox="1"/>
          <p:nvPr/>
        </p:nvSpPr>
        <p:spPr>
          <a:xfrm>
            <a:off x="7114401" y="4030330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4" name="Straight Connector 63">
            <a:extLst>
              <a:ext uri="{FF2B5EF4-FFF2-40B4-BE49-F238E27FC236}">
                <a16:creationId xmlns:a16="http://schemas.microsoft.com/office/drawing/2014/main" id="{7573C972-8523-4C63-B70B-ECCB16771DC1}"/>
              </a:ext>
            </a:extLst>
          </p:cNvPr>
          <p:cNvCxnSpPr>
            <a:cxnSpLocks/>
          </p:cNvCxnSpPr>
          <p:nvPr/>
        </p:nvCxnSpPr>
        <p:spPr>
          <a:xfrm>
            <a:off x="7442787" y="4435315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5" name="TextBox 38">
            <a:extLst>
              <a:ext uri="{FF2B5EF4-FFF2-40B4-BE49-F238E27FC236}">
                <a16:creationId xmlns:a16="http://schemas.microsoft.com/office/drawing/2014/main" id="{90C11596-0C0D-4D09-B955-A83377DF1627}"/>
              </a:ext>
            </a:extLst>
          </p:cNvPr>
          <p:cNvSpPr txBox="1"/>
          <p:nvPr/>
        </p:nvSpPr>
        <p:spPr>
          <a:xfrm>
            <a:off x="7114401" y="4293245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6" name="Straight Connector 65">
            <a:extLst>
              <a:ext uri="{FF2B5EF4-FFF2-40B4-BE49-F238E27FC236}">
                <a16:creationId xmlns:a16="http://schemas.microsoft.com/office/drawing/2014/main" id="{5AA36309-E27D-4C75-86D2-9F3ACEBDDA18}"/>
              </a:ext>
            </a:extLst>
          </p:cNvPr>
          <p:cNvCxnSpPr>
            <a:cxnSpLocks/>
          </p:cNvCxnSpPr>
          <p:nvPr/>
        </p:nvCxnSpPr>
        <p:spPr>
          <a:xfrm>
            <a:off x="7448923" y="3841568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7" name="TextBox 40">
            <a:extLst>
              <a:ext uri="{FF2B5EF4-FFF2-40B4-BE49-F238E27FC236}">
                <a16:creationId xmlns:a16="http://schemas.microsoft.com/office/drawing/2014/main" id="{DE1DEBD6-DFB8-4455-9F4F-1E2EDA07CD5F}"/>
              </a:ext>
            </a:extLst>
          </p:cNvPr>
          <p:cNvSpPr txBox="1"/>
          <p:nvPr/>
        </p:nvSpPr>
        <p:spPr>
          <a:xfrm>
            <a:off x="7120537" y="369949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8" name="Straight Connector 67">
            <a:extLst>
              <a:ext uri="{FF2B5EF4-FFF2-40B4-BE49-F238E27FC236}">
                <a16:creationId xmlns:a16="http://schemas.microsoft.com/office/drawing/2014/main" id="{4DEBC606-A2EC-4857-AB81-5B4471EB48D3}"/>
              </a:ext>
            </a:extLst>
          </p:cNvPr>
          <p:cNvCxnSpPr>
            <a:cxnSpLocks/>
          </p:cNvCxnSpPr>
          <p:nvPr/>
        </p:nvCxnSpPr>
        <p:spPr>
          <a:xfrm>
            <a:off x="7442787" y="3602902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9" name="TextBox 42">
            <a:extLst>
              <a:ext uri="{FF2B5EF4-FFF2-40B4-BE49-F238E27FC236}">
                <a16:creationId xmlns:a16="http://schemas.microsoft.com/office/drawing/2014/main" id="{6BFFF768-05BD-405D-B42D-A403DAFEA0BE}"/>
              </a:ext>
            </a:extLst>
          </p:cNvPr>
          <p:cNvSpPr txBox="1"/>
          <p:nvPr/>
        </p:nvSpPr>
        <p:spPr>
          <a:xfrm>
            <a:off x="7114401" y="3481151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0" name="Straight Connector 69">
            <a:extLst>
              <a:ext uri="{FF2B5EF4-FFF2-40B4-BE49-F238E27FC236}">
                <a16:creationId xmlns:a16="http://schemas.microsoft.com/office/drawing/2014/main" id="{3D4F869E-8501-48DD-8C36-14319408F421}"/>
              </a:ext>
            </a:extLst>
          </p:cNvPr>
          <p:cNvCxnSpPr>
            <a:cxnSpLocks/>
          </p:cNvCxnSpPr>
          <p:nvPr/>
        </p:nvCxnSpPr>
        <p:spPr>
          <a:xfrm>
            <a:off x="7442787" y="3470002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1" name="TextBox 42">
            <a:extLst>
              <a:ext uri="{FF2B5EF4-FFF2-40B4-BE49-F238E27FC236}">
                <a16:creationId xmlns:a16="http://schemas.microsoft.com/office/drawing/2014/main" id="{88385E00-4218-4519-BB5E-D22AE7255787}"/>
              </a:ext>
            </a:extLst>
          </p:cNvPr>
          <p:cNvSpPr txBox="1"/>
          <p:nvPr/>
        </p:nvSpPr>
        <p:spPr>
          <a:xfrm>
            <a:off x="7029441" y="3321159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559753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2</Words>
  <Application>Microsoft Office PowerPoint</Application>
  <PresentationFormat>Widescreen</PresentationFormat>
  <Paragraphs>3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Symbo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asmin Carvalho Schäfer</dc:creator>
  <cp:lastModifiedBy>mnagata</cp:lastModifiedBy>
  <cp:revision>8</cp:revision>
  <dcterms:created xsi:type="dcterms:W3CDTF">2024-08-12T13:06:21Z</dcterms:created>
  <dcterms:modified xsi:type="dcterms:W3CDTF">2024-08-13T17:07:19Z</dcterms:modified>
</cp:coreProperties>
</file>